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70" d="100"/>
          <a:sy n="170" d="100"/>
        </p:scale>
        <p:origin x="2400" y="36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5AA5F-B06A-41E0-9853-2354FC4B9464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C0F4C-AD73-4247-BC02-74BFC6EFD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0464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5AA5F-B06A-41E0-9853-2354FC4B9464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C0F4C-AD73-4247-BC02-74BFC6EFD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068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5AA5F-B06A-41E0-9853-2354FC4B9464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C0F4C-AD73-4247-BC02-74BFC6EFD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563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5AA5F-B06A-41E0-9853-2354FC4B9464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C0F4C-AD73-4247-BC02-74BFC6EFD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827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5AA5F-B06A-41E0-9853-2354FC4B9464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C0F4C-AD73-4247-BC02-74BFC6EFD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593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5AA5F-B06A-41E0-9853-2354FC4B9464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C0F4C-AD73-4247-BC02-74BFC6EFD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575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5AA5F-B06A-41E0-9853-2354FC4B9464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C0F4C-AD73-4247-BC02-74BFC6EFD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086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5AA5F-B06A-41E0-9853-2354FC4B9464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C0F4C-AD73-4247-BC02-74BFC6EFD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879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5AA5F-B06A-41E0-9853-2354FC4B9464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C0F4C-AD73-4247-BC02-74BFC6EFD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95236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5AA5F-B06A-41E0-9853-2354FC4B9464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C0F4C-AD73-4247-BC02-74BFC6EFD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472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5AA5F-B06A-41E0-9853-2354FC4B9464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C0F4C-AD73-4247-BC02-74BFC6EFD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6750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65AA5F-B06A-41E0-9853-2354FC4B9464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9C0F4C-AD73-4247-BC02-74BFC6EFD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01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163" y="0"/>
            <a:ext cx="8828087" cy="687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133600" y="2743200"/>
            <a:ext cx="1980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ctin for Fig. S1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867400" y="2743200"/>
            <a:ext cx="1980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ctin for Fig. S1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057400" y="5194852"/>
            <a:ext cx="1980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ctin for Fig. S1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847179" y="5182188"/>
            <a:ext cx="1992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ctin for Fig. S1D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5235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9000" contrast="2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3788" y="-7938"/>
            <a:ext cx="4414837" cy="68738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352800" y="2927866"/>
            <a:ext cx="2044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LRP1 for Fig. S1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42556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13000" contrast="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3788" y="0"/>
            <a:ext cx="4414837" cy="687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549131" y="5029200"/>
            <a:ext cx="2056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LRP1 for Fig. </a:t>
            </a:r>
            <a:r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t>S1D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08018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30</Words>
  <Application>Microsoft Office PowerPoint</Application>
  <PresentationFormat>On-screen Show (4:3)</PresentationFormat>
  <Paragraphs>6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a-Chen  Liu</dc:creator>
  <cp:lastModifiedBy>Chia-Chen  Liu</cp:lastModifiedBy>
  <cp:revision>5</cp:revision>
  <dcterms:created xsi:type="dcterms:W3CDTF">2016-09-30T14:52:24Z</dcterms:created>
  <dcterms:modified xsi:type="dcterms:W3CDTF">2016-09-30T15:57:17Z</dcterms:modified>
</cp:coreProperties>
</file>